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3"/>
  </p:notesMasterIdLst>
  <p:sldIdLst>
    <p:sldId id="413" r:id="rId2"/>
    <p:sldId id="307" r:id="rId3"/>
    <p:sldId id="412" r:id="rId4"/>
    <p:sldId id="258" r:id="rId5"/>
    <p:sldId id="259" r:id="rId6"/>
    <p:sldId id="306" r:id="rId7"/>
    <p:sldId id="416" r:id="rId8"/>
    <p:sldId id="417" r:id="rId9"/>
    <p:sldId id="418" r:id="rId10"/>
    <p:sldId id="419" r:id="rId11"/>
    <p:sldId id="265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8920"/>
    <p:restoredTop sz="94543"/>
  </p:normalViewPr>
  <p:slideViewPr>
    <p:cSldViewPr snapToGrid="0" snapToObjects="1">
      <p:cViewPr varScale="1">
        <p:scale>
          <a:sx n="99" d="100"/>
          <a:sy n="99" d="100"/>
        </p:scale>
        <p:origin x="200" y="3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6F22E49-0CC8-4D43-B455-E5F3BF2D6C14}" type="datetimeFigureOut">
              <a:rPr lang="en-US" smtClean="0"/>
              <a:t>8/25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EE31FE3-43F3-CB4D-870A-5F1911E802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93069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A4EC93-A17C-704B-90ED-66C1561DE57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0A9C53D-E228-0747-85E6-C624E0694C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0841D3-5174-9748-8F5B-AFFB27F9F2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EB9EE-A519-0E46-9772-3F241B3C81D2}" type="datetimeFigureOut">
              <a:rPr lang="en-US" smtClean="0"/>
              <a:t>8/2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4885FA-F5F4-714F-BA58-0D29F85DC5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F42686-845F-084A-BB8D-78693503BA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FB8C2-1274-2045-905B-53FEDA63D8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8275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8B71E3-2BDE-B74A-B262-64E83DDE7D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1552FD9-39CA-0849-A4DC-F6EA0AB2596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7A801D-77E6-5049-B77C-08C04C2AB9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EB9EE-A519-0E46-9772-3F241B3C81D2}" type="datetimeFigureOut">
              <a:rPr lang="en-US" smtClean="0"/>
              <a:t>8/2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216103-9845-7746-BB2D-383538987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F414D0-837F-7F4C-9562-0D293D51D3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FB8C2-1274-2045-905B-53FEDA63D8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08434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A2E9D7E-6AC3-4D47-8A3E-F091CBF348A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30938F8-4DBC-B644-91B2-CCD70889165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36F55A-37BA-5546-BA5D-BEB4BE5C2D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EB9EE-A519-0E46-9772-3F241B3C81D2}" type="datetimeFigureOut">
              <a:rPr lang="en-US" smtClean="0"/>
              <a:t>8/2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43316A-AB8E-D243-9F85-560AD009C5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6EAA94-5A3F-8B4B-890A-9D66062D40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FB8C2-1274-2045-905B-53FEDA63D8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63122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334B49-704C-3941-8738-D434155514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C64AEE-015E-BF4B-8542-9B25239738D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8E567A-5910-A041-A03A-B41F3CD93E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EB9EE-A519-0E46-9772-3F241B3C81D2}" type="datetimeFigureOut">
              <a:rPr lang="en-US" smtClean="0"/>
              <a:t>8/2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278B08-219D-404F-BC3B-D2B7FB5AF8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C7E6C9-6FC9-2D41-B7C3-14AD631CA2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FB8C2-1274-2045-905B-53FEDA63D8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5747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6AF3D2-A323-1949-8DE3-D50B9EDD76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731C81D-51EC-F641-801C-8A369DB2A3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39798D-55EA-5A4B-A05A-8023754438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EB9EE-A519-0E46-9772-3F241B3C81D2}" type="datetimeFigureOut">
              <a:rPr lang="en-US" smtClean="0"/>
              <a:t>8/2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18783A-BD99-2C45-9F9C-F7BEB83513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D3BC0B-AC3C-ED41-B817-6DCAC1FB8A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FB8C2-1274-2045-905B-53FEDA63D8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63318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5785E3-9903-3544-AD5F-46A758B081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CEF3BD-316D-B240-9D43-49C66FF08E3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14BC786-088B-3B46-B4E5-39BDA3242CC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B60E5A-0544-9A48-BE99-6922C45454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EB9EE-A519-0E46-9772-3F241B3C81D2}" type="datetimeFigureOut">
              <a:rPr lang="en-US" smtClean="0"/>
              <a:t>8/25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B7A1B4-082A-5647-83BD-330577F88A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D357608-CDDF-504F-A5C9-B2835B0938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FB8C2-1274-2045-905B-53FEDA63D8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89933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54E98D-C9D0-7D4F-8610-8355B614DB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5CBCDB-E848-AB4B-85B8-0A62FA0942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6FDDEE5-DAC1-EB4C-82BA-4DB0AB6EE3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78AC207-B037-9E47-961B-2B3861A1F4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4E0E028-F8E4-6245-AD92-57D1640AFFA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9C15793-F311-0241-B934-3D0E0B8472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EB9EE-A519-0E46-9772-3F241B3C81D2}" type="datetimeFigureOut">
              <a:rPr lang="en-US" smtClean="0"/>
              <a:t>8/25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BDDD635-1D8B-3548-B37E-4C9B6FA127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956653D-9138-134D-9335-871FA12620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FB8C2-1274-2045-905B-53FEDA63D8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31546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128B97-4ACE-AC4D-8EBE-ED0367B210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1BCC376-6BFD-2D48-A6F6-A77904BA67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EB9EE-A519-0E46-9772-3F241B3C81D2}" type="datetimeFigureOut">
              <a:rPr lang="en-US" smtClean="0"/>
              <a:t>8/25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5B43240-71A9-9C45-91D6-956A82BB87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7ADD207-4CC8-874C-8E6C-49DB956006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FB8C2-1274-2045-905B-53FEDA63D8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1781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D1A9D6B-3945-AA4D-A154-076446DC7C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EB9EE-A519-0E46-9772-3F241B3C81D2}" type="datetimeFigureOut">
              <a:rPr lang="en-US" smtClean="0"/>
              <a:t>8/25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4CDA950-D4AF-BD42-96DD-BD655B4ED2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F4EA4F5-AE4C-C140-88C4-A49CAC2502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FB8C2-1274-2045-905B-53FEDA63D8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8185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F9567C-DD74-8E4A-A645-249C1758D6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2CEE20-7C64-B640-B2B2-62B6B52B62A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47A604E-B364-B244-91BB-EF8700CC5B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B7C25F-CDE0-9B4F-AD4F-67B43EBFE2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EB9EE-A519-0E46-9772-3F241B3C81D2}" type="datetimeFigureOut">
              <a:rPr lang="en-US" smtClean="0"/>
              <a:t>8/25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66FE4B-EB58-704B-A189-D390F72651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BA7572-65B6-7E46-A22C-B1CCD120EF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FB8C2-1274-2045-905B-53FEDA63D8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5248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A6669D-F6ED-CF46-817E-7222326860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5D30393-F14D-1C4D-96BE-83E10D95CDB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F7007A7-4348-4F4C-A7E7-DE23B9AE208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F4DAAA2-2200-C04E-AB5A-D47D6A617B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EB9EE-A519-0E46-9772-3F241B3C81D2}" type="datetimeFigureOut">
              <a:rPr lang="en-US" smtClean="0"/>
              <a:t>8/25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06BE93-D44F-9545-9FC9-854ED73908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235274-4E1A-974C-9389-C1CF935765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FB8C2-1274-2045-905B-53FEDA63D8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8768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3BCEAD7-B80D-7342-B545-661B0E74F9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FED17B-F949-3447-8494-AE221986A1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10DABC-D457-2040-BA43-9D00898B9DB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CEB9EE-A519-0E46-9772-3F241B3C81D2}" type="datetimeFigureOut">
              <a:rPr lang="en-US" smtClean="0"/>
              <a:t>8/2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928147-7BE9-AF46-83D9-4E296AA89BB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8AF04D-AD50-7C49-A6D2-61F7339CD7E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8FB8C2-1274-2045-905B-53FEDA63D8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50914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7CA2EF-0D0A-BC45-9C52-308629663B0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373487"/>
            <a:ext cx="9144000" cy="6099600"/>
          </a:xfrm>
        </p:spPr>
        <p:txBody>
          <a:bodyPr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Analysis of data from the PALOMA-3 trial confirms the efficacy of palbociclib and offers alternatives for novel assessment of clinical trials</a:t>
            </a:r>
            <a:b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[SUPPLEMENTAL FIGURES]</a:t>
            </a:r>
            <a:b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b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2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eline Yeh</a:t>
            </a:r>
            <a:r>
              <a:rPr lang="en-US" sz="24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,4</a:t>
            </a:r>
            <a:br>
              <a:rPr lang="en-US" sz="2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</a:br>
            <a:r>
              <a:rPr lang="en-US" sz="24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engxi</a:t>
            </a:r>
            <a:r>
              <a:rPr lang="en-US" sz="2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Zhou</a:t>
            </a:r>
            <a:r>
              <a:rPr lang="en-US" sz="24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,4</a:t>
            </a:r>
            <a:br>
              <a:rPr lang="en-US" sz="2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</a:br>
            <a:r>
              <a:rPr lang="en-US" sz="2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eil Bapodra</a:t>
            </a:r>
            <a:r>
              <a:rPr lang="en-US" sz="24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3</a:t>
            </a:r>
            <a:br>
              <a:rPr lang="en-US" sz="2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</a:br>
            <a:r>
              <a:rPr lang="es-ES" sz="24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awn</a:t>
            </a:r>
            <a:r>
              <a:rPr lang="es-ES" sz="2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Hershman</a:t>
            </a:r>
            <a:r>
              <a:rPr lang="es-ES" sz="24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</a:t>
            </a:r>
            <a:br>
              <a:rPr lang="en-US" sz="2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</a:br>
            <a:r>
              <a:rPr lang="es-ES" sz="2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dward Espinal</a:t>
            </a:r>
            <a:r>
              <a:rPr lang="es-ES" sz="24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5</a:t>
            </a:r>
            <a:br>
              <a:rPr lang="en-US" sz="2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</a:br>
            <a:r>
              <a:rPr lang="es-ES" sz="2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arina Moran</a:t>
            </a:r>
            <a:r>
              <a:rPr lang="es-ES" sz="24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5</a:t>
            </a:r>
            <a:br>
              <a:rPr lang="en-US" sz="2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</a:br>
            <a:r>
              <a:rPr lang="es-ES" sz="24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aria</a:t>
            </a:r>
            <a:r>
              <a:rPr lang="es-ES" sz="2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Rivero</a:t>
            </a:r>
            <a:r>
              <a:rPr lang="es-ES" sz="24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5</a:t>
            </a:r>
            <a:br>
              <a:rPr lang="en-US" sz="2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</a:br>
            <a:r>
              <a:rPr lang="es-ES" sz="2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ito Fojo</a:t>
            </a:r>
            <a:r>
              <a:rPr lang="es-ES" sz="24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,3</a:t>
            </a:r>
            <a:br>
              <a:rPr lang="en-US" sz="2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</a:br>
            <a:r>
              <a:rPr lang="es-ES" sz="2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san E. Bates</a:t>
            </a:r>
            <a:r>
              <a:rPr lang="es-ES" sz="24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,3,6</a:t>
            </a:r>
            <a:endParaRPr lang="en-US" sz="3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512240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9258EA5-E7CF-9940-8F11-7E388633F9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4408" y="141537"/>
            <a:ext cx="11267941" cy="634713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7E3EB3C-E07D-684A-955C-7D9DFC56E863}"/>
              </a:ext>
            </a:extLst>
          </p:cNvPr>
          <p:cNvSpPr txBox="1"/>
          <p:nvPr/>
        </p:nvSpPr>
        <p:spPr>
          <a:xfrm>
            <a:off x="9532298" y="6488668"/>
            <a:ext cx="2659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7</a:t>
            </a:r>
          </a:p>
        </p:txBody>
      </p:sp>
    </p:spTree>
    <p:extLst>
      <p:ext uri="{BB962C8B-B14F-4D97-AF65-F5344CB8AC3E}">
        <p14:creationId xmlns:p14="http://schemas.microsoft.com/office/powerpoint/2010/main" val="227330860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6311596-64AF-144C-9F29-0B727E0E28EC}"/>
              </a:ext>
            </a:extLst>
          </p:cNvPr>
          <p:cNvSpPr txBox="1"/>
          <p:nvPr/>
        </p:nvSpPr>
        <p:spPr>
          <a:xfrm>
            <a:off x="9275817" y="6488668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8</a:t>
            </a:r>
          </a:p>
        </p:txBody>
      </p:sp>
      <p:pic>
        <p:nvPicPr>
          <p:cNvPr id="5" name="Picture 4" descr="A graph of different colored lines&#10;&#10;Description automatically generated">
            <a:extLst>
              <a:ext uri="{FF2B5EF4-FFF2-40B4-BE49-F238E27FC236}">
                <a16:creationId xmlns:a16="http://schemas.microsoft.com/office/drawing/2014/main" id="{A5018331-F60A-5144-D539-0D1EFF406F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0035" y="1093046"/>
            <a:ext cx="10531929" cy="43883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60964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21ACB66-4ADA-7547-8699-B4C2D38A9842}"/>
              </a:ext>
            </a:extLst>
          </p:cNvPr>
          <p:cNvSpPr txBox="1"/>
          <p:nvPr/>
        </p:nvSpPr>
        <p:spPr>
          <a:xfrm>
            <a:off x="9634332" y="6488668"/>
            <a:ext cx="25399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1</a:t>
            </a:r>
          </a:p>
        </p:txBody>
      </p:sp>
      <p:graphicFrame>
        <p:nvGraphicFramePr>
          <p:cNvPr id="6" name="Table 6">
            <a:extLst>
              <a:ext uri="{FF2B5EF4-FFF2-40B4-BE49-F238E27FC236}">
                <a16:creationId xmlns:a16="http://schemas.microsoft.com/office/drawing/2014/main" id="{17947100-0A5C-5F4A-BE97-32069F8F72E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21083954"/>
              </p:ext>
            </p:extLst>
          </p:nvPr>
        </p:nvGraphicFramePr>
        <p:xfrm>
          <a:off x="2796208" y="1123560"/>
          <a:ext cx="6599584" cy="516402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179852">
                  <a:extLst>
                    <a:ext uri="{9D8B030D-6E8A-4147-A177-3AD203B41FA5}">
                      <a16:colId xmlns:a16="http://schemas.microsoft.com/office/drawing/2014/main" val="2114155535"/>
                    </a:ext>
                  </a:extLst>
                </a:gridCol>
                <a:gridCol w="3419732">
                  <a:extLst>
                    <a:ext uri="{9D8B030D-6E8A-4147-A177-3AD203B41FA5}">
                      <a16:colId xmlns:a16="http://schemas.microsoft.com/office/drawing/2014/main" val="1830852510"/>
                    </a:ext>
                  </a:extLst>
                </a:gridCol>
              </a:tblGrid>
              <a:tr h="360052">
                <a:tc>
                  <a:txBody>
                    <a:bodyPr/>
                    <a:lstStyle/>
                    <a:p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7599" marR="117599" marT="58799" marB="58799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LOMA 3</a:t>
                      </a:r>
                    </a:p>
                  </a:txBody>
                  <a:tcPr marL="117599" marR="117599" marT="58799" marB="58799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5985259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erimental Arm (Size)</a:t>
                      </a:r>
                    </a:p>
                  </a:txBody>
                  <a:tcPr marL="117599" marR="117599" marT="58799" marB="58799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lbociclib + </a:t>
                      </a:r>
                      <a:r>
                        <a:rPr lang="en-US" sz="1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lvestrant</a:t>
                      </a:r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261)</a:t>
                      </a:r>
                    </a:p>
                  </a:txBody>
                  <a:tcPr marL="117599" marR="117599" marT="58799" marB="58799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91846669"/>
                  </a:ext>
                </a:extLst>
              </a:tr>
              <a:tr h="183737">
                <a:tc>
                  <a:txBody>
                    <a:bodyPr/>
                    <a:lstStyle/>
                    <a:p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 Arm (Size)</a:t>
                      </a:r>
                    </a:p>
                  </a:txBody>
                  <a:tcPr marL="117599" marR="117599" marT="58799" marB="58799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lvestrant</a:t>
                      </a:r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132)</a:t>
                      </a:r>
                    </a:p>
                  </a:txBody>
                  <a:tcPr marL="117599" marR="117599" marT="58799" marB="58799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1623651"/>
                  </a:ext>
                </a:extLst>
              </a:tr>
              <a:tr h="180107">
                <a:tc>
                  <a:txBody>
                    <a:bodyPr/>
                    <a:lstStyle/>
                    <a:p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udy Phase</a:t>
                      </a:r>
                    </a:p>
                  </a:txBody>
                  <a:tcPr marL="117599" marR="117599" marT="58799" marB="58799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117599" marR="117599" marT="58799" marB="58799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102953"/>
                  </a:ext>
                </a:extLst>
              </a:tr>
              <a:tr h="360052">
                <a:tc>
                  <a:txBody>
                    <a:bodyPr/>
                    <a:lstStyle/>
                    <a:p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 Population</a:t>
                      </a:r>
                    </a:p>
                  </a:txBody>
                  <a:tcPr marL="117599" marR="117599" marT="58799" marB="58799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+/HER2-</a:t>
                      </a:r>
                    </a:p>
                  </a:txBody>
                  <a:tcPr marL="117599" marR="117599" marT="58799" marB="58799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0229472"/>
                  </a:ext>
                </a:extLst>
              </a:tr>
              <a:tr h="360052">
                <a:tc>
                  <a:txBody>
                    <a:bodyPr/>
                    <a:lstStyle/>
                    <a:p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e of Therapy</a:t>
                      </a:r>
                    </a:p>
                  </a:txBody>
                  <a:tcPr marL="117599" marR="117599" marT="58799" marB="58799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u="sng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</a:t>
                      </a:r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2</a:t>
                      </a:r>
                    </a:p>
                  </a:txBody>
                  <a:tcPr marL="117599" marR="117599" marT="58799" marB="58799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8929144"/>
                  </a:ext>
                </a:extLst>
              </a:tr>
              <a:tr h="360052">
                <a:tc>
                  <a:txBody>
                    <a:bodyPr/>
                    <a:lstStyle/>
                    <a:p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ary Endpoint</a:t>
                      </a:r>
                    </a:p>
                  </a:txBody>
                  <a:tcPr marL="117599" marR="117599" marT="58799" marB="58799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FS</a:t>
                      </a:r>
                    </a:p>
                  </a:txBody>
                  <a:tcPr marL="117599" marR="117599" marT="58799" marB="58799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5701838"/>
                  </a:ext>
                </a:extLst>
              </a:tr>
              <a:tr h="237557">
                <a:tc>
                  <a:txBody>
                    <a:bodyPr/>
                    <a:lstStyle/>
                    <a:p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utcome (Months, 95%CI)</a:t>
                      </a:r>
                    </a:p>
                  </a:txBody>
                  <a:tcPr marL="117599" marR="117599" marT="58799" marB="58799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5 (9.2 – 11.0) vs 4.6 (3.5 – 5.6)</a:t>
                      </a:r>
                    </a:p>
                  </a:txBody>
                  <a:tcPr marL="117599" marR="117599" marT="58799" marB="58799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53859772"/>
                  </a:ext>
                </a:extLst>
              </a:tr>
              <a:tr h="150785">
                <a:tc>
                  <a:txBody>
                    <a:bodyPr/>
                    <a:lstStyle/>
                    <a:p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zard Ratio</a:t>
                      </a:r>
                    </a:p>
                  </a:txBody>
                  <a:tcPr marL="117599" marR="117599" marT="58799" marB="58799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 (0.36 – 0.59); P&lt;0.0001</a:t>
                      </a:r>
                    </a:p>
                  </a:txBody>
                  <a:tcPr marL="117599" marR="117599" marT="58799" marB="58799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9763442"/>
                  </a:ext>
                </a:extLst>
              </a:tr>
              <a:tr h="360052">
                <a:tc>
                  <a:txBody>
                    <a:bodyPr/>
                    <a:lstStyle/>
                    <a:p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condary Endpoint</a:t>
                      </a:r>
                    </a:p>
                  </a:txBody>
                  <a:tcPr marL="117599" marR="117599" marT="58799" marB="58799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, OR, </a:t>
                      </a:r>
                      <a:r>
                        <a:rPr lang="en-US" sz="1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tc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7599" marR="117599" marT="58799" marB="58799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50080810"/>
                  </a:ext>
                </a:extLst>
              </a:tr>
              <a:tr h="154702">
                <a:tc>
                  <a:txBody>
                    <a:bodyPr/>
                    <a:lstStyle/>
                    <a:p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condary Endpoint Available</a:t>
                      </a:r>
                    </a:p>
                  </a:txBody>
                  <a:tcPr marL="117599" marR="117599" marT="58799" marB="58799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</a:p>
                  </a:txBody>
                  <a:tcPr marL="117599" marR="117599" marT="58799" marB="58799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8315703"/>
                  </a:ext>
                </a:extLst>
              </a:tr>
              <a:tr h="360052">
                <a:tc>
                  <a:txBody>
                    <a:bodyPr/>
                    <a:lstStyle/>
                    <a:p>
                      <a:r>
                        <a:rPr lang="en-US" sz="16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inicalTrails.gov</a:t>
                      </a:r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Identifier</a:t>
                      </a:r>
                    </a:p>
                  </a:txBody>
                  <a:tcPr marL="117599" marR="117599" marT="58799" marB="58799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T01942135</a:t>
                      </a:r>
                    </a:p>
                  </a:txBody>
                  <a:tcPr marL="117599" marR="117599" marT="58799" marB="58799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765455"/>
                  </a:ext>
                </a:extLst>
              </a:tr>
              <a:tr h="602507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ote, the data provided for analysis was a large fraction of but not the entire clinical trial explaining the difference between our numbers and those in </a:t>
                      </a:r>
                      <a:r>
                        <a:rPr lang="en-US" sz="16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linicalTrials.gov</a:t>
                      </a:r>
                      <a:endParaRPr lang="en-US" sz="1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0" marR="95250" marT="47625" marB="47625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4982307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DE8EEDCF-0A11-3F5E-E824-4F9632129DE0}"/>
              </a:ext>
            </a:extLst>
          </p:cNvPr>
          <p:cNvSpPr txBox="1"/>
          <p:nvPr/>
        </p:nvSpPr>
        <p:spPr>
          <a:xfrm>
            <a:off x="519659" y="385748"/>
            <a:ext cx="4221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Table 1. Trial Characteristics</a:t>
            </a:r>
          </a:p>
        </p:txBody>
      </p:sp>
    </p:spTree>
    <p:extLst>
      <p:ext uri="{BB962C8B-B14F-4D97-AF65-F5344CB8AC3E}">
        <p14:creationId xmlns:p14="http://schemas.microsoft.com/office/powerpoint/2010/main" val="17474684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A421A0CE-9DE0-E480-B6D9-F82637C8A11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90707918"/>
              </p:ext>
            </p:extLst>
          </p:nvPr>
        </p:nvGraphicFramePr>
        <p:xfrm>
          <a:off x="829597" y="767583"/>
          <a:ext cx="10300985" cy="4560316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2686294">
                  <a:extLst>
                    <a:ext uri="{9D8B030D-6E8A-4147-A177-3AD203B41FA5}">
                      <a16:colId xmlns:a16="http://schemas.microsoft.com/office/drawing/2014/main" val="1356480924"/>
                    </a:ext>
                  </a:extLst>
                </a:gridCol>
                <a:gridCol w="1015292">
                  <a:extLst>
                    <a:ext uri="{9D8B030D-6E8A-4147-A177-3AD203B41FA5}">
                      <a16:colId xmlns:a16="http://schemas.microsoft.com/office/drawing/2014/main" val="1996617916"/>
                    </a:ext>
                  </a:extLst>
                </a:gridCol>
                <a:gridCol w="1332571">
                  <a:extLst>
                    <a:ext uri="{9D8B030D-6E8A-4147-A177-3AD203B41FA5}">
                      <a16:colId xmlns:a16="http://schemas.microsoft.com/office/drawing/2014/main" val="1824618984"/>
                    </a:ext>
                  </a:extLst>
                </a:gridCol>
                <a:gridCol w="1438331">
                  <a:extLst>
                    <a:ext uri="{9D8B030D-6E8A-4147-A177-3AD203B41FA5}">
                      <a16:colId xmlns:a16="http://schemas.microsoft.com/office/drawing/2014/main" val="2790814818"/>
                    </a:ext>
                  </a:extLst>
                </a:gridCol>
                <a:gridCol w="1332571">
                  <a:extLst>
                    <a:ext uri="{9D8B030D-6E8A-4147-A177-3AD203B41FA5}">
                      <a16:colId xmlns:a16="http://schemas.microsoft.com/office/drawing/2014/main" val="2525001087"/>
                    </a:ext>
                  </a:extLst>
                </a:gridCol>
                <a:gridCol w="1247963">
                  <a:extLst>
                    <a:ext uri="{9D8B030D-6E8A-4147-A177-3AD203B41FA5}">
                      <a16:colId xmlns:a16="http://schemas.microsoft.com/office/drawing/2014/main" val="3257727433"/>
                    </a:ext>
                  </a:extLst>
                </a:gridCol>
                <a:gridCol w="1247963">
                  <a:extLst>
                    <a:ext uri="{9D8B030D-6E8A-4147-A177-3AD203B41FA5}">
                      <a16:colId xmlns:a16="http://schemas.microsoft.com/office/drawing/2014/main" val="2786621795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pplemental Table 2 - 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portion of Evaluable Patients with </a:t>
                      </a:r>
                      <a:r>
                        <a:rPr lang="en-US" sz="16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alues Slower Than Doubling Time Thresholds</a:t>
                      </a:r>
                    </a:p>
                  </a:txBody>
                  <a:tcPr marL="68580" marR="68580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600" b="1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600" b="1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600" b="1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600" b="1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600" b="1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600" b="1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2779342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16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N</a:t>
                      </a:r>
                      <a:endParaRPr lang="en-US" sz="1600" b="1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alyzed N</a:t>
                      </a:r>
                      <a:endParaRPr lang="en-US" sz="1600" b="1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valuable N</a:t>
                      </a:r>
                      <a:endParaRPr lang="en-US" sz="1600" b="1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sz="1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with DT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1 year</a:t>
                      </a:r>
                      <a:endParaRPr lang="en-US" sz="1600" b="1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sz="1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with DT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2 year</a:t>
                      </a:r>
                      <a:endParaRPr lang="en-US" sz="1600" b="1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sz="1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with DT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3 </a:t>
                      </a:r>
                      <a:r>
                        <a:rPr lang="en-US" sz="1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ar</a:t>
                      </a:r>
                      <a:endParaRPr lang="en-US" sz="1600" b="1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874069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</a:t>
                      </a:r>
                      <a:endParaRPr lang="en-US" sz="1600" b="1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6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6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6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6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6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6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9136790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lbociclib + </a:t>
                      </a:r>
                      <a:r>
                        <a:rPr lang="en-US" sz="16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lvestrant</a:t>
                      </a:r>
                      <a:endParaRPr lang="en-US" sz="1600" b="1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1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8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1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7 (51%)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 (28%)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 (11%)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541485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cebo + </a:t>
                      </a:r>
                      <a:r>
                        <a:rPr lang="en-US" sz="16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lvestrant</a:t>
                      </a:r>
                      <a:endParaRPr lang="en-US" sz="1600" b="1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2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7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 (31%)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 (17%)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8%)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168319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nsitive</a:t>
                      </a:r>
                      <a:endParaRPr lang="en-US" sz="1600" b="1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6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6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6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6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6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6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8805454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lbociclib + </a:t>
                      </a:r>
                      <a:r>
                        <a:rPr lang="en-US" sz="16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lvestrant</a:t>
                      </a:r>
                      <a:endParaRPr lang="en-US" sz="1600" b="1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5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1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7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 (52%)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 (29%)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 (11%)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583407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cebo + </a:t>
                      </a:r>
                      <a:r>
                        <a:rPr lang="en-US" sz="16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lvestrant</a:t>
                      </a:r>
                      <a:endParaRPr lang="en-US" sz="1600" b="1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1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 (32%)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 (17%)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 (9%)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7518836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istant</a:t>
                      </a:r>
                      <a:endParaRPr lang="en-US" sz="1600" b="1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6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6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6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6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6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6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4998187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lbociclib + </a:t>
                      </a:r>
                      <a:r>
                        <a:rPr lang="en-US" sz="16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lvestrant</a:t>
                      </a:r>
                      <a:endParaRPr lang="en-US" sz="1600" b="1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 (45%)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 (25%)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 (14%)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583974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cebo + </a:t>
                      </a:r>
                      <a:r>
                        <a:rPr lang="en-US" sz="16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lvestrant</a:t>
                      </a:r>
                      <a:endParaRPr lang="en-US" sz="1600" b="1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 (25%)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 (15%)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 (5%)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72322777"/>
                  </a:ext>
                </a:extLst>
              </a:tr>
              <a:tr h="0">
                <a:tc gridSpan="7">
                  <a:txBody>
                    <a:bodyPr/>
                    <a:lstStyle/>
                    <a:p>
                      <a:pPr marL="114300" marR="0" indent="-11430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  <a:tabLst/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 N: All patients in the study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114300" marR="0" indent="-11430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  <a:tabLst/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nalyzed N: All patients with sufficient data for analysis (excluding those with no measurements, 1 measurement or 2 points less than 20% difference)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114300" marR="0" indent="-11430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  <a:tabLst/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valuable N: All patients with a fit (excluding not fits)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114300" marR="0" indent="-11430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  <a:tabLst/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he percentages were based on the Evaluable N.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76" marR="36576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6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/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6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/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6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/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6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/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6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/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6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9525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451060794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E2C782DC-6B46-F1D5-61DB-75494F6A9953}"/>
              </a:ext>
            </a:extLst>
          </p:cNvPr>
          <p:cNvSpPr txBox="1"/>
          <p:nvPr/>
        </p:nvSpPr>
        <p:spPr>
          <a:xfrm>
            <a:off x="9634332" y="6488668"/>
            <a:ext cx="25399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2</a:t>
            </a:r>
          </a:p>
        </p:txBody>
      </p:sp>
    </p:spTree>
    <p:extLst>
      <p:ext uri="{BB962C8B-B14F-4D97-AF65-F5344CB8AC3E}">
        <p14:creationId xmlns:p14="http://schemas.microsoft.com/office/powerpoint/2010/main" val="39222756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584CBFEB-9815-E44C-8E9B-0AD17492D4D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45758" y="0"/>
            <a:ext cx="5100484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D9DECFE-FAFC-FE47-904B-366287C96530}"/>
              </a:ext>
            </a:extLst>
          </p:cNvPr>
          <p:cNvSpPr txBox="1"/>
          <p:nvPr/>
        </p:nvSpPr>
        <p:spPr>
          <a:xfrm>
            <a:off x="9518372" y="6488668"/>
            <a:ext cx="2659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</a:p>
        </p:txBody>
      </p:sp>
    </p:spTree>
    <p:extLst>
      <p:ext uri="{BB962C8B-B14F-4D97-AF65-F5344CB8AC3E}">
        <p14:creationId xmlns:p14="http://schemas.microsoft.com/office/powerpoint/2010/main" val="31865716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Graphical user interface&#10;&#10;Description automatically generated with medium confidence">
            <a:extLst>
              <a:ext uri="{FF2B5EF4-FFF2-40B4-BE49-F238E27FC236}">
                <a16:creationId xmlns:a16="http://schemas.microsoft.com/office/drawing/2014/main" id="{7C64720B-D949-FD41-9D50-B172B4B3357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71750" y="273050"/>
            <a:ext cx="7048500" cy="63119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E087C14-CC80-654F-AF34-D630392AE886}"/>
              </a:ext>
            </a:extLst>
          </p:cNvPr>
          <p:cNvSpPr txBox="1"/>
          <p:nvPr/>
        </p:nvSpPr>
        <p:spPr>
          <a:xfrm>
            <a:off x="9506649" y="6488668"/>
            <a:ext cx="26853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</a:p>
        </p:txBody>
      </p:sp>
    </p:spTree>
    <p:extLst>
      <p:ext uri="{BB962C8B-B14F-4D97-AF65-F5344CB8AC3E}">
        <p14:creationId xmlns:p14="http://schemas.microsoft.com/office/powerpoint/2010/main" val="26269490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2C076F0-8F7E-904D-A8D3-C13A1C1EAE3D}"/>
              </a:ext>
            </a:extLst>
          </p:cNvPr>
          <p:cNvSpPr txBox="1"/>
          <p:nvPr/>
        </p:nvSpPr>
        <p:spPr>
          <a:xfrm>
            <a:off x="9497677" y="6474792"/>
            <a:ext cx="26853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0AA254E1-B00B-9D43-9134-4EADE2E1421E}"/>
              </a:ext>
            </a:extLst>
          </p:cNvPr>
          <p:cNvGrpSpPr/>
          <p:nvPr/>
        </p:nvGrpSpPr>
        <p:grpSpPr>
          <a:xfrm>
            <a:off x="926409" y="147984"/>
            <a:ext cx="8229600" cy="6537739"/>
            <a:chOff x="926409" y="147984"/>
            <a:chExt cx="8229600" cy="6537739"/>
          </a:xfrm>
        </p:grpSpPr>
        <p:pic>
          <p:nvPicPr>
            <p:cNvPr id="3" name="Picture 2" descr="Chart, line chart&#10;&#10;Description automatically generated">
              <a:extLst>
                <a:ext uri="{FF2B5EF4-FFF2-40B4-BE49-F238E27FC236}">
                  <a16:creationId xmlns:a16="http://schemas.microsoft.com/office/drawing/2014/main" id="{F6FE1F44-B55F-4643-A94E-E4173663651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10628"/>
            <a:stretch/>
          </p:blipFill>
          <p:spPr>
            <a:xfrm>
              <a:off x="926409" y="147984"/>
              <a:ext cx="8229600" cy="6537739"/>
            </a:xfrm>
            <a:prstGeom prst="rect">
              <a:avLst/>
            </a:prstGeom>
          </p:spPr>
        </p:pic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56C7EE4E-C8E6-7744-87AE-C96326C323B7}"/>
                </a:ext>
              </a:extLst>
            </p:cNvPr>
            <p:cNvGrpSpPr/>
            <p:nvPr/>
          </p:nvGrpSpPr>
          <p:grpSpPr>
            <a:xfrm>
              <a:off x="5338139" y="365056"/>
              <a:ext cx="3448280" cy="930598"/>
              <a:chOff x="2357609" y="1730029"/>
              <a:chExt cx="3448280" cy="930598"/>
            </a:xfrm>
          </p:grpSpPr>
          <p:pic>
            <p:nvPicPr>
              <p:cNvPr id="7" name="Picture 6" descr="Chart, line chart&#10;&#10;Description automatically generated">
                <a:extLst>
                  <a:ext uri="{FF2B5EF4-FFF2-40B4-BE49-F238E27FC236}">
                    <a16:creationId xmlns:a16="http://schemas.microsoft.com/office/drawing/2014/main" id="{3003D8CD-3D0E-304E-A084-2C1A2CED7BA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55591" t="1991" b="91250"/>
              <a:stretch/>
            </p:blipFill>
            <p:spPr>
              <a:xfrm>
                <a:off x="2357609" y="2197077"/>
                <a:ext cx="3426247" cy="463550"/>
              </a:xfrm>
              <a:prstGeom prst="rect">
                <a:avLst/>
              </a:prstGeom>
            </p:spPr>
          </p:pic>
          <p:pic>
            <p:nvPicPr>
              <p:cNvPr id="8" name="Picture 7" descr="Chart, line chart&#10;&#10;Description automatically generated">
                <a:extLst>
                  <a:ext uri="{FF2B5EF4-FFF2-40B4-BE49-F238E27FC236}">
                    <a16:creationId xmlns:a16="http://schemas.microsoft.com/office/drawing/2014/main" id="{81B1C02A-2B33-6045-9B76-25F5CFA1E1A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0541" t="5111" r="45050" b="91250"/>
              <a:stretch/>
            </p:blipFill>
            <p:spPr>
              <a:xfrm>
                <a:off x="2379643" y="1969969"/>
                <a:ext cx="3426246" cy="249564"/>
              </a:xfrm>
              <a:prstGeom prst="rect">
                <a:avLst/>
              </a:prstGeom>
            </p:spPr>
          </p:pic>
          <p:pic>
            <p:nvPicPr>
              <p:cNvPr id="9" name="Picture 8" descr="Chart, line chart&#10;&#10;Description automatically generated">
                <a:extLst>
                  <a:ext uri="{FF2B5EF4-FFF2-40B4-BE49-F238E27FC236}">
                    <a16:creationId xmlns:a16="http://schemas.microsoft.com/office/drawing/2014/main" id="{85111190-45C9-A840-8151-B411BAA5214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0790" t="1710" r="49351" b="94651"/>
              <a:stretch/>
            </p:blipFill>
            <p:spPr>
              <a:xfrm>
                <a:off x="2387067" y="1730029"/>
                <a:ext cx="3323362" cy="249564"/>
              </a:xfrm>
              <a:prstGeom prst="rect">
                <a:avLst/>
              </a:prstGeom>
            </p:spPr>
          </p:pic>
          <p:sp>
            <p:nvSpPr>
              <p:cNvPr id="10" name="Oval 9">
                <a:extLst>
                  <a:ext uri="{FF2B5EF4-FFF2-40B4-BE49-F238E27FC236}">
                    <a16:creationId xmlns:a16="http://schemas.microsoft.com/office/drawing/2014/main" id="{0598467C-83FC-9642-9853-F993D3713989}"/>
                  </a:ext>
                </a:extLst>
              </p:cNvPr>
              <p:cNvSpPr/>
              <p:nvPr/>
            </p:nvSpPr>
            <p:spPr>
              <a:xfrm>
                <a:off x="3044791" y="1952321"/>
                <a:ext cx="67377" cy="54544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" name="Oval 10">
                <a:extLst>
                  <a:ext uri="{FF2B5EF4-FFF2-40B4-BE49-F238E27FC236}">
                    <a16:creationId xmlns:a16="http://schemas.microsoft.com/office/drawing/2014/main" id="{32FA8297-9585-AF43-BE66-08A3974E4AB7}"/>
                  </a:ext>
                </a:extLst>
              </p:cNvPr>
              <p:cNvSpPr/>
              <p:nvPr/>
            </p:nvSpPr>
            <p:spPr>
              <a:xfrm>
                <a:off x="4416383" y="1953929"/>
                <a:ext cx="67377" cy="54544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14376417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17DCB5D7-1B60-0E44-A94E-D57AC58D3C0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0750" y="128814"/>
            <a:ext cx="10350500" cy="64262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F2F41670-A1E3-5C44-9AE5-EB3C08A00833}"/>
              </a:ext>
            </a:extLst>
          </p:cNvPr>
          <p:cNvSpPr txBox="1"/>
          <p:nvPr/>
        </p:nvSpPr>
        <p:spPr>
          <a:xfrm>
            <a:off x="9484425" y="6474792"/>
            <a:ext cx="2659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4</a:t>
            </a:r>
          </a:p>
        </p:txBody>
      </p:sp>
    </p:spTree>
    <p:extLst>
      <p:ext uri="{BB962C8B-B14F-4D97-AF65-F5344CB8AC3E}">
        <p14:creationId xmlns:p14="http://schemas.microsoft.com/office/powerpoint/2010/main" val="208997982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E8570DFF-E43F-0446-8654-5E65BDB7148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0750" y="-2208"/>
            <a:ext cx="10350500" cy="64770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6BCDD74-E0CB-7046-845F-501E39008EBE}"/>
              </a:ext>
            </a:extLst>
          </p:cNvPr>
          <p:cNvSpPr txBox="1"/>
          <p:nvPr/>
        </p:nvSpPr>
        <p:spPr>
          <a:xfrm>
            <a:off x="9484425" y="6474792"/>
            <a:ext cx="2659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5</a:t>
            </a:r>
          </a:p>
        </p:txBody>
      </p:sp>
    </p:spTree>
    <p:extLst>
      <p:ext uri="{BB962C8B-B14F-4D97-AF65-F5344CB8AC3E}">
        <p14:creationId xmlns:p14="http://schemas.microsoft.com/office/powerpoint/2010/main" val="180094859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854FB87-2686-D34D-8229-87BAB26C94D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9236" y="0"/>
            <a:ext cx="10350500" cy="6477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1B4FD8E-BD88-574E-8D9A-27B306E4C414}"/>
              </a:ext>
            </a:extLst>
          </p:cNvPr>
          <p:cNvSpPr txBox="1"/>
          <p:nvPr/>
        </p:nvSpPr>
        <p:spPr>
          <a:xfrm>
            <a:off x="9484425" y="6474792"/>
            <a:ext cx="2659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6</a:t>
            </a:r>
          </a:p>
        </p:txBody>
      </p:sp>
    </p:spTree>
    <p:extLst>
      <p:ext uri="{BB962C8B-B14F-4D97-AF65-F5344CB8AC3E}">
        <p14:creationId xmlns:p14="http://schemas.microsoft.com/office/powerpoint/2010/main" val="18287337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92</TotalTime>
  <Words>418</Words>
  <Application>Microsoft Macintosh PowerPoint</Application>
  <PresentationFormat>Widescreen</PresentationFormat>
  <Paragraphs>96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Arial</vt:lpstr>
      <vt:lpstr>Calibri</vt:lpstr>
      <vt:lpstr>Calibri Light</vt:lpstr>
      <vt:lpstr>Office Theme</vt:lpstr>
      <vt:lpstr>Analysis of data from the PALOMA-3 trial confirms the efficacy of palbociclib and offers alternatives for novel assessment of clinical trials [SUPPLEMENTAL FIGURES]   Celine Yeh1,4 Mengxi Zhou2,4 Neil Bapodra3 Dawn Hershman1 Edward Espinal5 Marina Moran5 Maria Rivero5 Tito Fojo1,3 Susan E. Bates1,3,6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ojo, Antonio T.</dc:creator>
  <cp:lastModifiedBy>Fojo, Antonio T.</cp:lastModifiedBy>
  <cp:revision>92</cp:revision>
  <dcterms:created xsi:type="dcterms:W3CDTF">2021-05-13T19:51:53Z</dcterms:created>
  <dcterms:modified xsi:type="dcterms:W3CDTF">2023-08-26T02:20:20Z</dcterms:modified>
</cp:coreProperties>
</file>